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8" r:id="rId3"/>
  </p:sldIdLst>
  <p:sldSz cx="12192000" cy="25603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064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>
        <p:scale>
          <a:sx n="80" d="100"/>
          <a:sy n="80" d="100"/>
        </p:scale>
        <p:origin x="710" y="48"/>
      </p:cViewPr>
      <p:guideLst>
        <p:guide orient="horz" pos="8064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4190155"/>
            <a:ext cx="10363200" cy="891370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13447609"/>
            <a:ext cx="9144000" cy="6181511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9A56-9627-4C6C-9D2F-67BA0DB24AC9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7A44-F069-4F48-A522-B44F42A54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4358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9A56-9627-4C6C-9D2F-67BA0DB24AC9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7A44-F069-4F48-A522-B44F42A54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2688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1363133"/>
            <a:ext cx="2628900" cy="216975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1363133"/>
            <a:ext cx="7734300" cy="216975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9A56-9627-4C6C-9D2F-67BA0DB24AC9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7A44-F069-4F48-A522-B44F42A54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442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9A56-9627-4C6C-9D2F-67BA0DB24AC9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7A44-F069-4F48-A522-B44F42A54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182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6383028"/>
            <a:ext cx="10515600" cy="10650218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7134001"/>
            <a:ext cx="10515600" cy="5600698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9A56-9627-4C6C-9D2F-67BA0DB24AC9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7A44-F069-4F48-A522-B44F42A54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2552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6815667"/>
            <a:ext cx="5181600" cy="1624499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6815667"/>
            <a:ext cx="5181600" cy="1624499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9A56-9627-4C6C-9D2F-67BA0DB24AC9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7A44-F069-4F48-A522-B44F42A54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715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363139"/>
            <a:ext cx="10515600" cy="49487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6276342"/>
            <a:ext cx="5157787" cy="3075938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9352280"/>
            <a:ext cx="5157787" cy="1375579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6276342"/>
            <a:ext cx="5183188" cy="3075938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9352280"/>
            <a:ext cx="5183188" cy="1375579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9A56-9627-4C6C-9D2F-67BA0DB24AC9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7A44-F069-4F48-A522-B44F42A54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581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9A56-9627-4C6C-9D2F-67BA0DB24AC9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7A44-F069-4F48-A522-B44F42A54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825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9A56-9627-4C6C-9D2F-67BA0DB24AC9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7A44-F069-4F48-A522-B44F42A54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7279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706880"/>
            <a:ext cx="3932237" cy="597408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3686392"/>
            <a:ext cx="6172200" cy="181948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7680960"/>
            <a:ext cx="3932237" cy="1422992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9A56-9627-4C6C-9D2F-67BA0DB24AC9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7A44-F069-4F48-A522-B44F42A54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97712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706880"/>
            <a:ext cx="3932237" cy="597408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3686392"/>
            <a:ext cx="6172200" cy="181948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7680960"/>
            <a:ext cx="3932237" cy="1422992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9A56-9627-4C6C-9D2F-67BA0DB24AC9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57A44-F069-4F48-A522-B44F42A54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5111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1363139"/>
            <a:ext cx="10515600" cy="49487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6815667"/>
            <a:ext cx="10515600" cy="1624499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23730379"/>
            <a:ext cx="2743200" cy="13631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6F9A56-9627-4C6C-9D2F-67BA0DB24AC9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23730379"/>
            <a:ext cx="4114800" cy="13631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23730379"/>
            <a:ext cx="2743200" cy="13631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E57A44-F069-4F48-A522-B44F42A54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2757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3A419A4-8661-B300-A53F-503CAD7EEED3}"/>
              </a:ext>
            </a:extLst>
          </p:cNvPr>
          <p:cNvSpPr txBox="1"/>
          <p:nvPr/>
        </p:nvSpPr>
        <p:spPr>
          <a:xfrm>
            <a:off x="2186922" y="1469570"/>
            <a:ext cx="868790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/>
              <a:t>Figure S2. </a:t>
            </a:r>
            <a:r>
              <a:rPr lang="en-US" sz="2800" dirty="0"/>
              <a:t>KEGG pathway enrichment of the differentially expressed proteins in different treatment comparisons of cadmium-treated </a:t>
            </a:r>
            <a:r>
              <a:rPr lang="en-US" sz="2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Rhizoma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</a:t>
            </a:r>
            <a:r>
              <a:rPr lang="en-US" sz="2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Polygonati</a:t>
            </a:r>
            <a:r>
              <a:rPr lang="en-US" sz="2800" dirty="0"/>
              <a:t> </a:t>
            </a:r>
            <a:endParaRPr 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27435860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29A5E81-57E9-415A-ED49-C2BCDF230F4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00"/>
          <a:stretch/>
        </p:blipFill>
        <p:spPr>
          <a:xfrm>
            <a:off x="2262549" y="798830"/>
            <a:ext cx="9144000" cy="5943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7982B63-1A6E-8E63-166C-DD64BB633DC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00"/>
          <a:stretch/>
        </p:blipFill>
        <p:spPr>
          <a:xfrm>
            <a:off x="2262549" y="6858000"/>
            <a:ext cx="9144000" cy="5943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8AB63BC-FE80-2FF1-44B6-34204489E05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00"/>
          <a:stretch/>
        </p:blipFill>
        <p:spPr>
          <a:xfrm>
            <a:off x="2262549" y="18976340"/>
            <a:ext cx="9144000" cy="5943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437313E-A721-109B-0361-241FBE47E38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00"/>
          <a:stretch/>
        </p:blipFill>
        <p:spPr>
          <a:xfrm>
            <a:off x="2262549" y="12917170"/>
            <a:ext cx="9144000" cy="5943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893D3E6-4A43-6F1E-2B85-809A833A69D7}"/>
              </a:ext>
            </a:extLst>
          </p:cNvPr>
          <p:cNvSpPr txBox="1"/>
          <p:nvPr/>
        </p:nvSpPr>
        <p:spPr>
          <a:xfrm rot="16200000">
            <a:off x="94775" y="3331219"/>
            <a:ext cx="254268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1 vs D2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93B544C-4EA6-F884-C6F2-631B28288712}"/>
              </a:ext>
            </a:extLst>
          </p:cNvPr>
          <p:cNvSpPr txBox="1"/>
          <p:nvPr/>
        </p:nvSpPr>
        <p:spPr>
          <a:xfrm rot="16200000">
            <a:off x="94775" y="9240271"/>
            <a:ext cx="254268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1 vs D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8CE76DC-3866-D4F4-AA22-1BC3C3A2DDCD}"/>
              </a:ext>
            </a:extLst>
          </p:cNvPr>
          <p:cNvSpPr txBox="1"/>
          <p:nvPr/>
        </p:nvSpPr>
        <p:spPr>
          <a:xfrm rot="16200000">
            <a:off x="94775" y="15395508"/>
            <a:ext cx="254268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1 vs D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C15F4CE-A46F-4367-9CFA-83591030C97C}"/>
              </a:ext>
            </a:extLst>
          </p:cNvPr>
          <p:cNvSpPr txBox="1"/>
          <p:nvPr/>
        </p:nvSpPr>
        <p:spPr>
          <a:xfrm rot="16200000">
            <a:off x="94775" y="20917702"/>
            <a:ext cx="254268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1 vs D5</a:t>
            </a:r>
          </a:p>
        </p:txBody>
      </p:sp>
    </p:spTree>
    <p:extLst>
      <p:ext uri="{BB962C8B-B14F-4D97-AF65-F5344CB8AC3E}">
        <p14:creationId xmlns:p14="http://schemas.microsoft.com/office/powerpoint/2010/main" val="24626061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31</Words>
  <Application>Microsoft Office PowerPoint</Application>
  <PresentationFormat>Custom</PresentationFormat>
  <Paragraphs>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s</dc:creator>
  <cp:lastModifiedBy>Authors</cp:lastModifiedBy>
  <cp:revision>3</cp:revision>
  <dcterms:created xsi:type="dcterms:W3CDTF">2022-11-14T10:23:05Z</dcterms:created>
  <dcterms:modified xsi:type="dcterms:W3CDTF">2023-01-11T18:03:48Z</dcterms:modified>
</cp:coreProperties>
</file>